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000" autoAdjust="0"/>
    <p:restoredTop sz="94660"/>
  </p:normalViewPr>
  <p:slideViewPr>
    <p:cSldViewPr snapToGrid="0">
      <p:cViewPr varScale="1">
        <p:scale>
          <a:sx n="74" d="100"/>
          <a:sy n="74" d="100"/>
        </p:scale>
        <p:origin x="576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84C406-6E00-4587-AEFB-B324AFD9461A}" type="datetimeFigureOut">
              <a:rPr lang="en-US" smtClean="0"/>
              <a:t>7/4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5D1B2E-70F4-4DA9-BED4-235F0D2D6C9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3735059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84C406-6E00-4587-AEFB-B324AFD9461A}" type="datetimeFigureOut">
              <a:rPr lang="en-US" smtClean="0"/>
              <a:t>7/4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5D1B2E-70F4-4DA9-BED4-235F0D2D6C9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7862918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84C406-6E00-4587-AEFB-B324AFD9461A}" type="datetimeFigureOut">
              <a:rPr lang="en-US" smtClean="0"/>
              <a:t>7/4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5D1B2E-70F4-4DA9-BED4-235F0D2D6C9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7601718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84C406-6E00-4587-AEFB-B324AFD9461A}" type="datetimeFigureOut">
              <a:rPr lang="en-US" smtClean="0"/>
              <a:t>7/4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5D1B2E-70F4-4DA9-BED4-235F0D2D6C9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8775523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84C406-6E00-4587-AEFB-B324AFD9461A}" type="datetimeFigureOut">
              <a:rPr lang="en-US" smtClean="0"/>
              <a:t>7/4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5D1B2E-70F4-4DA9-BED4-235F0D2D6C9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1822536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84C406-6E00-4587-AEFB-B324AFD9461A}" type="datetimeFigureOut">
              <a:rPr lang="en-US" smtClean="0"/>
              <a:t>7/4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5D1B2E-70F4-4DA9-BED4-235F0D2D6C9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2692962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84C406-6E00-4587-AEFB-B324AFD9461A}" type="datetimeFigureOut">
              <a:rPr lang="en-US" smtClean="0"/>
              <a:t>7/4/202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5D1B2E-70F4-4DA9-BED4-235F0D2D6C9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5521719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84C406-6E00-4587-AEFB-B324AFD9461A}" type="datetimeFigureOut">
              <a:rPr lang="en-US" smtClean="0"/>
              <a:t>7/4/202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5D1B2E-70F4-4DA9-BED4-235F0D2D6C9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6039749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84C406-6E00-4587-AEFB-B324AFD9461A}" type="datetimeFigureOut">
              <a:rPr lang="en-US" smtClean="0"/>
              <a:t>7/4/202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5D1B2E-70F4-4DA9-BED4-235F0D2D6C9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2719288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84C406-6E00-4587-AEFB-B324AFD9461A}" type="datetimeFigureOut">
              <a:rPr lang="en-US" smtClean="0"/>
              <a:t>7/4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5D1B2E-70F4-4DA9-BED4-235F0D2D6C9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2881999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84C406-6E00-4587-AEFB-B324AFD9461A}" type="datetimeFigureOut">
              <a:rPr lang="en-US" smtClean="0"/>
              <a:t>7/4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5D1B2E-70F4-4DA9-BED4-235F0D2D6C9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7890649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084C406-6E00-4587-AEFB-B324AFD9461A}" type="datetimeFigureOut">
              <a:rPr lang="en-US" smtClean="0"/>
              <a:t>7/4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F5D1B2E-70F4-4DA9-BED4-235F0D2D6C9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9814690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8" name="Espace réservé du contenu 7">
            <a:extLst>
              <a:ext uri="{FF2B5EF4-FFF2-40B4-BE49-F238E27FC236}">
                <a16:creationId xmlns:a16="http://schemas.microsoft.com/office/drawing/2014/main" xmlns="" id="{08FAF1D9-D39C-114A-80DA-D076E9F62403}"/>
              </a:ext>
            </a:extLst>
          </p:cNvPr>
          <p:cNvGraphicFramePr>
            <a:graphicFrameLocks noGrp="1"/>
          </p:cNvGraphicFramePr>
          <p:nvPr>
            <p:ph idx="1"/>
            <p:extLst/>
          </p:nvPr>
        </p:nvGraphicFramePr>
        <p:xfrm>
          <a:off x="1302150" y="2202084"/>
          <a:ext cx="9568541" cy="2710389"/>
        </p:xfrm>
        <a:graphic>
          <a:graphicData uri="http://schemas.openxmlformats.org/drawingml/2006/table">
            <a:tbl>
              <a:tblPr firstRow="1" bandRow="1">
                <a:tableStyleId>{C083E6E3-FA7D-4D7B-A595-EF9225AFEA82}</a:tableStyleId>
              </a:tblPr>
              <a:tblGrid>
                <a:gridCol w="990929">
                  <a:extLst>
                    <a:ext uri="{9D8B030D-6E8A-4147-A177-3AD203B41FA5}">
                      <a16:colId xmlns:a16="http://schemas.microsoft.com/office/drawing/2014/main" xmlns="" val="572455860"/>
                    </a:ext>
                  </a:extLst>
                </a:gridCol>
                <a:gridCol w="1429602">
                  <a:extLst>
                    <a:ext uri="{9D8B030D-6E8A-4147-A177-3AD203B41FA5}">
                      <a16:colId xmlns:a16="http://schemas.microsoft.com/office/drawing/2014/main" xmlns="" val="1483095525"/>
                    </a:ext>
                  </a:extLst>
                </a:gridCol>
                <a:gridCol w="1429602">
                  <a:extLst>
                    <a:ext uri="{9D8B030D-6E8A-4147-A177-3AD203B41FA5}">
                      <a16:colId xmlns:a16="http://schemas.microsoft.com/office/drawing/2014/main" xmlns="" val="723686225"/>
                    </a:ext>
                  </a:extLst>
                </a:gridCol>
                <a:gridCol w="1429602">
                  <a:extLst>
                    <a:ext uri="{9D8B030D-6E8A-4147-A177-3AD203B41FA5}">
                      <a16:colId xmlns:a16="http://schemas.microsoft.com/office/drawing/2014/main" xmlns="" val="3454509952"/>
                    </a:ext>
                  </a:extLst>
                </a:gridCol>
                <a:gridCol w="1429602">
                  <a:extLst>
                    <a:ext uri="{9D8B030D-6E8A-4147-A177-3AD203B41FA5}">
                      <a16:colId xmlns:a16="http://schemas.microsoft.com/office/drawing/2014/main" xmlns="" val="1521930969"/>
                    </a:ext>
                  </a:extLst>
                </a:gridCol>
                <a:gridCol w="1429602">
                  <a:extLst>
                    <a:ext uri="{9D8B030D-6E8A-4147-A177-3AD203B41FA5}">
                      <a16:colId xmlns:a16="http://schemas.microsoft.com/office/drawing/2014/main" xmlns="" val="3609759790"/>
                    </a:ext>
                  </a:extLst>
                </a:gridCol>
                <a:gridCol w="1429602">
                  <a:extLst>
                    <a:ext uri="{9D8B030D-6E8A-4147-A177-3AD203B41FA5}">
                      <a16:colId xmlns:a16="http://schemas.microsoft.com/office/drawing/2014/main" xmlns="" val="4261792510"/>
                    </a:ext>
                  </a:extLst>
                </a:gridCol>
              </a:tblGrid>
              <a:tr h="522513">
                <a:tc>
                  <a:txBody>
                    <a:bodyPr/>
                    <a:lstStyle/>
                    <a:p>
                      <a:pPr algn="ctr" fontAlgn="b"/>
                      <a:r>
                        <a:rPr lang="fr-FR" sz="1200" b="0" u="none" strike="noStrike" dirty="0" err="1">
                          <a:solidFill>
                            <a:srgbClr val="000000"/>
                          </a:solidFill>
                          <a:effectLst/>
                        </a:rPr>
                        <a:t>Mottling</a:t>
                      </a:r>
                      <a:r>
                        <a:rPr lang="fr-FR" sz="12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 score</a:t>
                      </a:r>
                      <a:endParaRPr lang="fr-FR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200" b="0" u="none" strike="noStrike" dirty="0" err="1">
                          <a:solidFill>
                            <a:srgbClr val="000000"/>
                          </a:solidFill>
                          <a:effectLst/>
                        </a:rPr>
                        <a:t>Specificity</a:t>
                      </a:r>
                      <a:endParaRPr lang="fr-FR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200" b="0" u="none" strike="noStrike" dirty="0" err="1">
                          <a:solidFill>
                            <a:srgbClr val="000000"/>
                          </a:solidFill>
                          <a:effectLst/>
                        </a:rPr>
                        <a:t>Sensitivity</a:t>
                      </a:r>
                      <a:endParaRPr lang="fr-FR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200" b="0" u="none" strike="noStrike" dirty="0" err="1">
                          <a:solidFill>
                            <a:srgbClr val="000000"/>
                          </a:solidFill>
                          <a:effectLst/>
                        </a:rPr>
                        <a:t>Negative</a:t>
                      </a:r>
                      <a:r>
                        <a:rPr lang="fr-FR" sz="12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 </a:t>
                      </a:r>
                      <a:r>
                        <a:rPr lang="fr-FR" sz="1200" b="0" u="none" strike="noStrike" dirty="0" err="1">
                          <a:solidFill>
                            <a:srgbClr val="000000"/>
                          </a:solidFill>
                          <a:effectLst/>
                        </a:rPr>
                        <a:t>predictive</a:t>
                      </a:r>
                      <a:r>
                        <a:rPr lang="fr-FR" sz="12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 value</a:t>
                      </a:r>
                      <a:endParaRPr lang="fr-FR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2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Positive </a:t>
                      </a:r>
                      <a:r>
                        <a:rPr lang="fr-FR" sz="1200" b="0" u="none" strike="noStrike" dirty="0" err="1">
                          <a:solidFill>
                            <a:srgbClr val="000000"/>
                          </a:solidFill>
                          <a:effectLst/>
                        </a:rPr>
                        <a:t>predictive</a:t>
                      </a:r>
                      <a:r>
                        <a:rPr lang="fr-FR" sz="12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 value</a:t>
                      </a:r>
                      <a:endParaRPr lang="fr-FR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200" b="0" u="none" strike="noStrike" dirty="0" err="1">
                          <a:solidFill>
                            <a:srgbClr val="000000"/>
                          </a:solidFill>
                          <a:effectLst/>
                        </a:rPr>
                        <a:t>Likelihood</a:t>
                      </a:r>
                      <a:r>
                        <a:rPr lang="fr-FR" sz="12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 Ratio +</a:t>
                      </a:r>
                      <a:endParaRPr lang="fr-FR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200" b="0" u="none" strike="noStrike" dirty="0" err="1">
                          <a:solidFill>
                            <a:srgbClr val="000000"/>
                          </a:solidFill>
                          <a:effectLst/>
                        </a:rPr>
                        <a:t>Likelihood</a:t>
                      </a:r>
                      <a:r>
                        <a:rPr lang="fr-FR" sz="12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 Ratio-</a:t>
                      </a:r>
                      <a:endParaRPr lang="fr-FR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xmlns="" val="2345493082"/>
                  </a:ext>
                </a:extLst>
              </a:tr>
              <a:tr h="364646">
                <a:tc>
                  <a:txBody>
                    <a:bodyPr/>
                    <a:lstStyle/>
                    <a:p>
                      <a:pPr algn="ctr" fontAlgn="b"/>
                      <a:r>
                        <a:rPr lang="fr-FR" sz="1200" b="1" u="none" strike="noStrike" dirty="0">
                          <a:solidFill>
                            <a:srgbClr val="000000"/>
                          </a:solidFill>
                          <a:effectLst/>
                        </a:rPr>
                        <a:t>0</a:t>
                      </a:r>
                      <a:endParaRPr lang="fr-FR" sz="12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2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0.00</a:t>
                      </a:r>
                      <a:endParaRPr lang="fr-FR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2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1.00</a:t>
                      </a:r>
                      <a:endParaRPr lang="fr-FR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200" b="0" u="none" strike="noStrike">
                          <a:solidFill>
                            <a:srgbClr val="000000"/>
                          </a:solidFill>
                          <a:effectLst/>
                        </a:rPr>
                        <a:t>NA</a:t>
                      </a:r>
                      <a:endParaRPr lang="fr-FR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2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0.40</a:t>
                      </a:r>
                      <a:endParaRPr lang="fr-FR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2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1.00</a:t>
                      </a:r>
                      <a:endParaRPr lang="fr-FR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2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NA</a:t>
                      </a:r>
                      <a:endParaRPr lang="fr-FR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xmlns="" val="4130734858"/>
                  </a:ext>
                </a:extLst>
              </a:tr>
              <a:tr h="364646">
                <a:tc>
                  <a:txBody>
                    <a:bodyPr/>
                    <a:lstStyle/>
                    <a:p>
                      <a:pPr algn="ctr" fontAlgn="b"/>
                      <a:r>
                        <a:rPr lang="fr-FR" sz="1200" b="1" u="none" strike="noStrike" dirty="0">
                          <a:solidFill>
                            <a:srgbClr val="000000"/>
                          </a:solidFill>
                          <a:effectLst/>
                        </a:rPr>
                        <a:t>1</a:t>
                      </a:r>
                      <a:endParaRPr lang="fr-FR" sz="12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2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0.72</a:t>
                      </a:r>
                      <a:endParaRPr lang="fr-FR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2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0.66</a:t>
                      </a:r>
                      <a:endParaRPr lang="fr-FR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2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0.76</a:t>
                      </a:r>
                      <a:endParaRPr lang="fr-FR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2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0.62</a:t>
                      </a:r>
                      <a:endParaRPr lang="fr-FR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2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2.38</a:t>
                      </a:r>
                      <a:endParaRPr lang="fr-FR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2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0.47</a:t>
                      </a:r>
                      <a:endParaRPr lang="fr-FR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xmlns="" val="2885313382"/>
                  </a:ext>
                </a:extLst>
              </a:tr>
              <a:tr h="364646">
                <a:tc>
                  <a:txBody>
                    <a:bodyPr/>
                    <a:lstStyle/>
                    <a:p>
                      <a:pPr algn="ctr" fontAlgn="b"/>
                      <a:r>
                        <a:rPr lang="fr-FR" sz="1200" b="1" u="none" strike="noStrike" dirty="0">
                          <a:solidFill>
                            <a:srgbClr val="000000"/>
                          </a:solidFill>
                          <a:effectLst/>
                        </a:rPr>
                        <a:t>2</a:t>
                      </a:r>
                      <a:endParaRPr lang="fr-FR" sz="12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2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0.86</a:t>
                      </a:r>
                      <a:endParaRPr lang="fr-FR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2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0.45</a:t>
                      </a:r>
                      <a:endParaRPr lang="fr-FR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2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0.70</a:t>
                      </a:r>
                      <a:endParaRPr lang="fr-FR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2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0.69</a:t>
                      </a:r>
                      <a:endParaRPr lang="fr-FR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2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3.28</a:t>
                      </a:r>
                      <a:endParaRPr lang="fr-FR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2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0.63</a:t>
                      </a:r>
                      <a:endParaRPr lang="fr-FR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xmlns="" val="3400553168"/>
                  </a:ext>
                </a:extLst>
              </a:tr>
              <a:tr h="364646">
                <a:tc>
                  <a:txBody>
                    <a:bodyPr/>
                    <a:lstStyle/>
                    <a:p>
                      <a:pPr algn="ctr" fontAlgn="b"/>
                      <a:r>
                        <a:rPr lang="fr-FR" sz="1200" b="1" u="none" strike="noStrike" dirty="0">
                          <a:solidFill>
                            <a:srgbClr val="000000"/>
                          </a:solidFill>
                          <a:effectLst/>
                        </a:rPr>
                        <a:t>3</a:t>
                      </a:r>
                      <a:endParaRPr lang="fr-FR" sz="12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2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0.95</a:t>
                      </a:r>
                      <a:endParaRPr lang="fr-FR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2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0.32</a:t>
                      </a:r>
                      <a:endParaRPr lang="fr-FR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2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0.67</a:t>
                      </a:r>
                      <a:endParaRPr lang="fr-FR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2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0.82</a:t>
                      </a:r>
                      <a:endParaRPr lang="fr-FR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2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6.89</a:t>
                      </a:r>
                      <a:endParaRPr lang="fr-FR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2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0.71</a:t>
                      </a:r>
                      <a:endParaRPr lang="fr-FR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xmlns="" val="1753895444"/>
                  </a:ext>
                </a:extLst>
              </a:tr>
              <a:tr h="364646">
                <a:tc>
                  <a:txBody>
                    <a:bodyPr/>
                    <a:lstStyle/>
                    <a:p>
                      <a:pPr algn="ctr" fontAlgn="b"/>
                      <a:r>
                        <a:rPr lang="fr-FR" sz="1200" b="1" u="none" strike="noStrike" dirty="0">
                          <a:solidFill>
                            <a:srgbClr val="000000"/>
                          </a:solidFill>
                          <a:effectLst/>
                        </a:rPr>
                        <a:t>4</a:t>
                      </a:r>
                      <a:endParaRPr lang="fr-FR" sz="12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2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0.97</a:t>
                      </a:r>
                      <a:endParaRPr lang="fr-FR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2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0.20</a:t>
                      </a:r>
                      <a:endParaRPr lang="fr-FR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2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0.64</a:t>
                      </a:r>
                      <a:endParaRPr lang="fr-FR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2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0.82</a:t>
                      </a:r>
                      <a:endParaRPr lang="fr-FR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2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6.65</a:t>
                      </a:r>
                      <a:endParaRPr lang="fr-FR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2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0.82</a:t>
                      </a:r>
                      <a:endParaRPr lang="fr-FR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xmlns="" val="1385754754"/>
                  </a:ext>
                </a:extLst>
              </a:tr>
              <a:tr h="364646">
                <a:tc>
                  <a:txBody>
                    <a:bodyPr/>
                    <a:lstStyle/>
                    <a:p>
                      <a:pPr algn="ctr" fontAlgn="b"/>
                      <a:r>
                        <a:rPr lang="fr-FR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2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1.00</a:t>
                      </a:r>
                      <a:endParaRPr lang="fr-FR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2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0.09</a:t>
                      </a:r>
                      <a:endParaRPr lang="fr-FR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2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0.62</a:t>
                      </a:r>
                      <a:endParaRPr lang="fr-FR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2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1.00</a:t>
                      </a:r>
                      <a:endParaRPr lang="fr-FR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200" b="0" u="none" strike="noStrike">
                          <a:solidFill>
                            <a:srgbClr val="000000"/>
                          </a:solidFill>
                          <a:effectLst/>
                        </a:rPr>
                        <a:t>Inf</a:t>
                      </a:r>
                      <a:endParaRPr lang="fr-FR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2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0.91</a:t>
                      </a:r>
                      <a:endParaRPr lang="fr-FR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xmlns="" val="999306722"/>
                  </a:ext>
                </a:extLst>
              </a:tr>
            </a:tbl>
          </a:graphicData>
        </a:graphic>
      </p:graphicFrame>
      <p:sp>
        <p:nvSpPr>
          <p:cNvPr id="6" name="Rectangle 5">
            <a:extLst>
              <a:ext uri="{FF2B5EF4-FFF2-40B4-BE49-F238E27FC236}">
                <a16:creationId xmlns:a16="http://schemas.microsoft.com/office/drawing/2014/main" xmlns="" id="{3CD3782A-2B47-C049-A61E-89B2401E3096}"/>
              </a:ext>
            </a:extLst>
          </p:cNvPr>
          <p:cNvSpPr/>
          <p:nvPr/>
        </p:nvSpPr>
        <p:spPr>
          <a:xfrm>
            <a:off x="456232" y="628456"/>
            <a:ext cx="1749197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fr-FR" dirty="0" err="1">
                <a:latin typeface="Arial" panose="020B0604020202020204" pitchFamily="34" charset="0"/>
                <a:cs typeface="Arial" panose="020B0604020202020204" pitchFamily="34" charset="0"/>
              </a:rPr>
              <a:t>Additional</a:t>
            </a:r>
            <a:r>
              <a:rPr lang="fr-FR" dirty="0">
                <a:latin typeface="Arial" panose="020B0604020202020204" pitchFamily="34" charset="0"/>
                <a:cs typeface="Arial" panose="020B0604020202020204" pitchFamily="34" charset="0"/>
              </a:rPr>
              <a:t> file 5</a:t>
            </a:r>
            <a:endParaRPr lang="fr-FR" dirty="0"/>
          </a:p>
        </p:txBody>
      </p:sp>
      <p:sp>
        <p:nvSpPr>
          <p:cNvPr id="2" name="ZoneTexte 1">
            <a:extLst>
              <a:ext uri="{FF2B5EF4-FFF2-40B4-BE49-F238E27FC236}">
                <a16:creationId xmlns:a16="http://schemas.microsoft.com/office/drawing/2014/main" xmlns="" id="{65665848-71F1-E74C-9433-9B931DAE86AC}"/>
              </a:ext>
            </a:extLst>
          </p:cNvPr>
          <p:cNvSpPr txBox="1"/>
          <p:nvPr/>
        </p:nvSpPr>
        <p:spPr>
          <a:xfrm>
            <a:off x="1169044" y="5855159"/>
            <a:ext cx="6512873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/>
              <a:t>Additional file 5.</a:t>
            </a:r>
            <a:r>
              <a:rPr lang="en-US" sz="1400" dirty="0"/>
              <a:t> Performances of cut-point values of the mottling score to predict PIHI</a:t>
            </a:r>
            <a:endParaRPr lang="fr-FR" sz="1400" dirty="0"/>
          </a:p>
          <a:p>
            <a:endParaRPr lang="fr-FR" sz="1400" dirty="0"/>
          </a:p>
        </p:txBody>
      </p:sp>
    </p:spTree>
    <p:extLst>
      <p:ext uri="{BB962C8B-B14F-4D97-AF65-F5344CB8AC3E}">
        <p14:creationId xmlns:p14="http://schemas.microsoft.com/office/powerpoint/2010/main" val="9777207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75</Words>
  <Application>Microsoft Office PowerPoint</Application>
  <PresentationFormat>Widescreen</PresentationFormat>
  <Paragraphs>5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aranya M.</dc:creator>
  <cp:lastModifiedBy>Saranya M.</cp:lastModifiedBy>
  <cp:revision>1</cp:revision>
  <dcterms:created xsi:type="dcterms:W3CDTF">2022-07-04T08:57:58Z</dcterms:created>
  <dcterms:modified xsi:type="dcterms:W3CDTF">2022-07-04T08:58:04Z</dcterms:modified>
</cp:coreProperties>
</file>